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tteo Allegretti" initials="MA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86CD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3814" autoAdjust="0"/>
    <p:restoredTop sz="94721"/>
  </p:normalViewPr>
  <p:slideViewPr>
    <p:cSldViewPr snapToGrid="0">
      <p:cViewPr>
        <p:scale>
          <a:sx n="400" d="100"/>
          <a:sy n="400" d="100"/>
        </p:scale>
        <p:origin x="-4566" y="-24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E9A2404-818C-40D7-8DBE-47D937F19B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54653DB2-055B-4A7A-8A86-79681222B49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5648EEC-A72A-4C9B-B15B-16EDB7165D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28/01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BED336B-1A1E-43A4-AEDB-57D4A47756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CD13BEB-DFFD-44C3-AC8D-0BA3A2B1FE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820043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F43E248-C438-45BA-96E4-29D668AD8A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CDDE2779-F21D-4C0F-9412-65A71C12ED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7D05AE3-D50D-447E-A04B-0BA2C062CD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28/01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E8CB01C-E7E1-4BBF-A6BA-FB921ED1DE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A5588B9-7D2A-41AB-80C8-93361B4F16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330353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E106062B-0A26-42AA-B236-104F7AD4456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A54CF406-2180-449D-937E-C10C065812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0BC78AB-A4A3-4C33-9A89-0A5FA2C1C4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28/01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6A33727-7BEC-49A5-B560-66C9E706FE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0CA9778-A646-4618-9D54-8CDA14D4A0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94592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6737542-C57B-48C2-BDA9-DFBDEC63D5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C7D6B9D-CFD5-4588-8190-A9B8E32240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53BD535-D95B-496A-ADC3-9287796400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28/01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21E8289-D9FA-470B-9C7F-2F5497BFEC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907CA2B-3838-4C04-9D17-70059F9FC8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959285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C43B77C-CA67-4B95-8E03-8FB7569CE7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EC2BA80-C826-470C-969E-D234ABE31E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7B993CD-D9A8-479E-9CFA-1BF8755224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28/01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14137FB-3764-4912-8FD7-20018B902A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B41DA86-47DF-490E-88CF-B1D67B761D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788209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6F12990-D7BB-4831-B653-8A4806633B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0FAF918-936D-46FA-8AB9-DBC7A027031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557822D-F6FF-4510-8383-843F8490B5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4EC0E7D-1952-4DA4-B5C6-7C5EF5D754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28/01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F96560A-4A9B-4DC3-97BE-07421F5122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81146A9-9763-4334-AF8F-26CB669DF1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823741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D9D9765-6FE6-4015-869E-22A715F521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921D052-04CE-42C2-A12B-8B87B394B3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2353D0E3-EA63-4501-929E-C4D7ABBE9C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CA007351-DE7B-4F6E-95A7-7C86DF8AD6F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4AABB126-B2B4-407A-9C1D-795F61AD918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D48923B7-D4C4-427D-AEDD-756548D1B7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28/01/20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9F0F043D-D292-452D-B2D2-50F17FD420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E2475619-2FCC-472F-A2A0-28E8AFF726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85419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0537DEE-8655-48BF-8B3D-2AE2FF8E32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797C19A5-ED2F-4055-8718-F887116CF7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28/01/20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A6415BA6-8B13-4629-9EAD-AF828B6036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50676B03-C6BC-40DF-A0A3-AFB417152D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682300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59978609-CB0F-4F42-81DA-0DC900777B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28/01/20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27CD3390-40EA-4915-945D-C637954C7A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03903CBE-4219-4145-8E28-7F39E2EAC2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25234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CAD9A49-1837-462B-B508-EE8497EB22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A4BF52A-BB74-4151-9E21-15920DC1E1A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47042EBD-49EE-46E0-A2F8-3D112C77CA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1820349-58E5-4E2B-9682-D085E5C1A2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28/01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84561D4E-E31C-461D-9F9F-F1590C1DBB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AE72D45-F389-4217-B8E9-58A4668226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209189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5737603-6D0C-4A72-8022-7F95A12467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C5672C7E-FD66-4317-95E9-E034CA03C5E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D3E89227-E64B-4581-AB68-E29DF803C1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107A73C-80F1-4F50-9C0B-E30FB2FBB3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28/01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820E1DC-31CF-42D4-BFE5-D811DBAD76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D0B406C-2D39-46C2-ACCA-BA8A685D3D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641691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516E30C4-68FA-4131-9621-FB080567D2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A499C65-45C6-4F93-A208-5346D03E6C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F867C32-125E-4DA9-AC0D-351BA0406F3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CB410B-6B5E-4D5C-9E34-FF8516CFAC5E}" type="datetimeFigureOut">
              <a:rPr lang="it-IT" smtClean="0"/>
              <a:t>28/01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5FC6645-E6D3-4493-B621-6CA11D0F0FE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925B74E-F75D-497F-99B0-911B19781A9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665460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0" name="Immagine 109">
            <a:extLst>
              <a:ext uri="{FF2B5EF4-FFF2-40B4-BE49-F238E27FC236}">
                <a16:creationId xmlns:a16="http://schemas.microsoft.com/office/drawing/2014/main" id="{6A9286F0-2A6D-4274-8EF4-D319D95C09A8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1752954" y="822798"/>
            <a:ext cx="1026000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1" name="Immagine 110">
            <a:extLst>
              <a:ext uri="{FF2B5EF4-FFF2-40B4-BE49-F238E27FC236}">
                <a16:creationId xmlns:a16="http://schemas.microsoft.com/office/drawing/2014/main" id="{9DAF625F-2F1E-485A-9FBB-10C69E1004E1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830332" y="825109"/>
            <a:ext cx="1026000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4" name="CasellaDiTesto 53">
            <a:extLst>
              <a:ext uri="{FF2B5EF4-FFF2-40B4-BE49-F238E27FC236}">
                <a16:creationId xmlns:a16="http://schemas.microsoft.com/office/drawing/2014/main" id="{63B491A5-0AC6-422A-9E22-DE796C9A6E28}"/>
              </a:ext>
            </a:extLst>
          </p:cNvPr>
          <p:cNvSpPr txBox="1"/>
          <p:nvPr/>
        </p:nvSpPr>
        <p:spPr>
          <a:xfrm>
            <a:off x="1815351" y="592165"/>
            <a:ext cx="9012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sz="800" i="1" kern="0" dirty="0">
                <a:solidFill>
                  <a:prstClr val="black"/>
                </a:solidFill>
              </a:rPr>
              <a:t>Brain </a:t>
            </a:r>
            <a:r>
              <a:rPr lang="it-IT" sz="800" i="1" kern="0" dirty="0" err="1">
                <a:solidFill>
                  <a:prstClr val="black"/>
                </a:solidFill>
              </a:rPr>
              <a:t>metastasis</a:t>
            </a:r>
            <a:endParaRPr kumimoji="0" lang="it-IT" sz="800" i="1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56" name="CasellaDiTesto 55">
            <a:extLst>
              <a:ext uri="{FF2B5EF4-FFF2-40B4-BE49-F238E27FC236}">
                <a16:creationId xmlns:a16="http://schemas.microsoft.com/office/drawing/2014/main" id="{7C8205A7-7FA2-4CE7-B3EE-6435A9AD5A68}"/>
              </a:ext>
            </a:extLst>
          </p:cNvPr>
          <p:cNvSpPr txBox="1"/>
          <p:nvPr/>
        </p:nvSpPr>
        <p:spPr>
          <a:xfrm>
            <a:off x="3131579" y="589375"/>
            <a:ext cx="4235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R="0" lvl="0" indent="0" algn="ctr" defTabSz="457200" fontAlgn="auto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800" i="1" kern="0">
                <a:solidFill>
                  <a:prstClr val="black"/>
                </a:solidFill>
              </a:defRPr>
            </a:lvl1pPr>
          </a:lstStyle>
          <a:p>
            <a:r>
              <a:rPr lang="it-IT" dirty="0"/>
              <a:t>Blood</a:t>
            </a:r>
          </a:p>
        </p:txBody>
      </p:sp>
      <p:sp>
        <p:nvSpPr>
          <p:cNvPr id="59" name="CasellaDiTesto 58">
            <a:extLst>
              <a:ext uri="{FF2B5EF4-FFF2-40B4-BE49-F238E27FC236}">
                <a16:creationId xmlns:a16="http://schemas.microsoft.com/office/drawing/2014/main" id="{1D3F3175-8D6C-41C1-B923-1A4FA871A25D}"/>
              </a:ext>
            </a:extLst>
          </p:cNvPr>
          <p:cNvSpPr txBox="1"/>
          <p:nvPr/>
        </p:nvSpPr>
        <p:spPr>
          <a:xfrm>
            <a:off x="1883479" y="1365509"/>
            <a:ext cx="7649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sz="600" kern="0" dirty="0">
                <a:solidFill>
                  <a:prstClr val="black"/>
                </a:solidFill>
              </a:rPr>
              <a:t>VAF (dPCR): 30.6%</a:t>
            </a:r>
          </a:p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600" b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VAF (NGS</a:t>
            </a:r>
            <a:r>
              <a:rPr lang="it-IT" sz="600" kern="0" dirty="0">
                <a:solidFill>
                  <a:prstClr val="black"/>
                </a:solidFill>
              </a:rPr>
              <a:t>): 30.8%</a:t>
            </a:r>
            <a:endParaRPr kumimoji="0" lang="it-IT" sz="600" b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60" name="CasellaDiTesto 59">
            <a:extLst>
              <a:ext uri="{FF2B5EF4-FFF2-40B4-BE49-F238E27FC236}">
                <a16:creationId xmlns:a16="http://schemas.microsoft.com/office/drawing/2014/main" id="{1C78921A-245A-44AD-AE40-07D4DBACC6D5}"/>
              </a:ext>
            </a:extLst>
          </p:cNvPr>
          <p:cNvSpPr txBox="1"/>
          <p:nvPr/>
        </p:nvSpPr>
        <p:spPr>
          <a:xfrm>
            <a:off x="2980090" y="1365509"/>
            <a:ext cx="7264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R="0" lvl="0" indent="0" algn="ctr" defTabSz="457200" fontAlgn="auto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600" kern="0">
                <a:solidFill>
                  <a:prstClr val="black"/>
                </a:solidFill>
              </a:defRPr>
            </a:lvl1pPr>
          </a:lstStyle>
          <a:p>
            <a:r>
              <a:rPr lang="it-IT" dirty="0"/>
              <a:t>VAF (dPCR): 0.0%</a:t>
            </a:r>
          </a:p>
          <a:p>
            <a:r>
              <a:rPr lang="it-IT" dirty="0"/>
              <a:t>VAF (NGS): 0.0%</a:t>
            </a:r>
          </a:p>
        </p:txBody>
      </p:sp>
      <p:sp>
        <p:nvSpPr>
          <p:cNvPr id="61" name="CasellaDiTesto 60">
            <a:extLst>
              <a:ext uri="{FF2B5EF4-FFF2-40B4-BE49-F238E27FC236}">
                <a16:creationId xmlns:a16="http://schemas.microsoft.com/office/drawing/2014/main" id="{C857E0C3-140F-4815-9EB8-DE69F3BE6142}"/>
              </a:ext>
            </a:extLst>
          </p:cNvPr>
          <p:cNvSpPr txBox="1"/>
          <p:nvPr/>
        </p:nvSpPr>
        <p:spPr>
          <a:xfrm>
            <a:off x="1883477" y="2204321"/>
            <a:ext cx="7649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R="0" lvl="0" indent="0" algn="ctr" defTabSz="457200" fontAlgn="auto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600" kern="0">
                <a:solidFill>
                  <a:prstClr val="black"/>
                </a:solidFill>
              </a:defRPr>
            </a:lvl1pPr>
          </a:lstStyle>
          <a:p>
            <a:r>
              <a:rPr lang="it-IT" dirty="0"/>
              <a:t>VAF (dPCR): 39.6%</a:t>
            </a:r>
          </a:p>
          <a:p>
            <a:r>
              <a:rPr lang="it-IT" dirty="0"/>
              <a:t>VAF (NGS): 34.2%</a:t>
            </a:r>
          </a:p>
        </p:txBody>
      </p:sp>
      <p:sp>
        <p:nvSpPr>
          <p:cNvPr id="67" name="CasellaDiTesto 66">
            <a:extLst>
              <a:ext uri="{FF2B5EF4-FFF2-40B4-BE49-F238E27FC236}">
                <a16:creationId xmlns:a16="http://schemas.microsoft.com/office/drawing/2014/main" id="{AAC6E562-0FDE-4D5D-BDE3-B7352DF2945D}"/>
              </a:ext>
            </a:extLst>
          </p:cNvPr>
          <p:cNvSpPr txBox="1"/>
          <p:nvPr/>
        </p:nvSpPr>
        <p:spPr>
          <a:xfrm>
            <a:off x="2980090" y="2204321"/>
            <a:ext cx="7264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R="0" lvl="0" indent="0" algn="ctr" defTabSz="457200" fontAlgn="auto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600" kern="0">
                <a:solidFill>
                  <a:prstClr val="black"/>
                </a:solidFill>
              </a:defRPr>
            </a:lvl1pPr>
          </a:lstStyle>
          <a:p>
            <a:r>
              <a:rPr lang="it-IT" dirty="0"/>
              <a:t>VAF (dPCR): 0.0%</a:t>
            </a:r>
          </a:p>
          <a:p>
            <a:r>
              <a:rPr lang="it-IT" dirty="0"/>
              <a:t>VAF (NGS): 0.0%</a:t>
            </a:r>
          </a:p>
        </p:txBody>
      </p:sp>
      <p:sp>
        <p:nvSpPr>
          <p:cNvPr id="104" name="CasellaDiTesto 103">
            <a:extLst>
              <a:ext uri="{FF2B5EF4-FFF2-40B4-BE49-F238E27FC236}">
                <a16:creationId xmlns:a16="http://schemas.microsoft.com/office/drawing/2014/main" id="{C3A9F112-F52F-4976-A41C-3CF9C60291C0}"/>
              </a:ext>
            </a:extLst>
          </p:cNvPr>
          <p:cNvSpPr txBox="1"/>
          <p:nvPr/>
        </p:nvSpPr>
        <p:spPr>
          <a:xfrm>
            <a:off x="1100991" y="956610"/>
            <a:ext cx="6174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457200">
              <a:defRPr/>
            </a:pPr>
            <a:r>
              <a:rPr lang="it-IT" sz="600" i="1" kern="0" dirty="0">
                <a:solidFill>
                  <a:prstClr val="black"/>
                </a:solidFill>
              </a:rPr>
              <a:t>dPCR </a:t>
            </a:r>
            <a:r>
              <a:rPr lang="it-IT" sz="600" i="1" kern="0" dirty="0" err="1">
                <a:solidFill>
                  <a:prstClr val="black"/>
                </a:solidFill>
              </a:rPr>
              <a:t>assay</a:t>
            </a:r>
            <a:r>
              <a:rPr lang="it-IT" sz="600" kern="0" dirty="0">
                <a:solidFill>
                  <a:prstClr val="black"/>
                </a:solidFill>
              </a:rPr>
              <a:t>: </a:t>
            </a:r>
          </a:p>
          <a:p>
            <a:pPr algn="ctr" defTabSz="457200">
              <a:defRPr/>
            </a:pPr>
            <a:r>
              <a:rPr lang="it-IT" sz="600" kern="0" dirty="0">
                <a:solidFill>
                  <a:prstClr val="black"/>
                </a:solidFill>
              </a:rPr>
              <a:t>ETV6 p.Y401D</a:t>
            </a:r>
          </a:p>
        </p:txBody>
      </p:sp>
      <p:sp>
        <p:nvSpPr>
          <p:cNvPr id="109" name="CasellaDiTesto 108">
            <a:extLst>
              <a:ext uri="{FF2B5EF4-FFF2-40B4-BE49-F238E27FC236}">
                <a16:creationId xmlns:a16="http://schemas.microsoft.com/office/drawing/2014/main" id="{B8014CA8-0721-4D24-AF86-0D7DF0EE215A}"/>
              </a:ext>
            </a:extLst>
          </p:cNvPr>
          <p:cNvSpPr txBox="1"/>
          <p:nvPr/>
        </p:nvSpPr>
        <p:spPr>
          <a:xfrm>
            <a:off x="1058244" y="1785784"/>
            <a:ext cx="6992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457200">
              <a:defRPr/>
            </a:pPr>
            <a:r>
              <a:rPr lang="it-IT" sz="600" i="1" kern="0" dirty="0">
                <a:solidFill>
                  <a:prstClr val="black"/>
                </a:solidFill>
              </a:rPr>
              <a:t>dPCR </a:t>
            </a:r>
            <a:r>
              <a:rPr lang="it-IT" sz="600" i="1" kern="0" dirty="0" err="1">
                <a:solidFill>
                  <a:prstClr val="black"/>
                </a:solidFill>
              </a:rPr>
              <a:t>assay</a:t>
            </a:r>
            <a:r>
              <a:rPr lang="it-IT" sz="600" kern="0" dirty="0">
                <a:solidFill>
                  <a:prstClr val="black"/>
                </a:solidFill>
              </a:rPr>
              <a:t>: </a:t>
            </a:r>
          </a:p>
          <a:p>
            <a:pPr algn="ctr" defTabSz="457200">
              <a:defRPr/>
            </a:pPr>
            <a:r>
              <a:rPr lang="it-IT" sz="600" kern="0" dirty="0">
                <a:solidFill>
                  <a:prstClr val="black"/>
                </a:solidFill>
              </a:rPr>
              <a:t>GATA3 p.M401V</a:t>
            </a:r>
          </a:p>
        </p:txBody>
      </p:sp>
      <p:pic>
        <p:nvPicPr>
          <p:cNvPr id="112" name="Immagine 111">
            <a:extLst>
              <a:ext uri="{FF2B5EF4-FFF2-40B4-BE49-F238E27FC236}">
                <a16:creationId xmlns:a16="http://schemas.microsoft.com/office/drawing/2014/main" id="{4DC56173-C461-42B1-8295-F870D5983EAC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830332" y="1654283"/>
            <a:ext cx="1026000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3" name="Immagine 112">
            <a:extLst>
              <a:ext uri="{FF2B5EF4-FFF2-40B4-BE49-F238E27FC236}">
                <a16:creationId xmlns:a16="http://schemas.microsoft.com/office/drawing/2014/main" id="{3BA03E69-A6D6-4411-8C57-7A97BFA59F2E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1752954" y="1654283"/>
            <a:ext cx="1026000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Rettangolo con angoli arrotondati 5">
            <a:extLst>
              <a:ext uri="{FF2B5EF4-FFF2-40B4-BE49-F238E27FC236}">
                <a16:creationId xmlns:a16="http://schemas.microsoft.com/office/drawing/2014/main" id="{11047621-0186-45B0-A0E1-03E373830D85}"/>
              </a:ext>
            </a:extLst>
          </p:cNvPr>
          <p:cNvSpPr/>
          <p:nvPr/>
        </p:nvSpPr>
        <p:spPr>
          <a:xfrm>
            <a:off x="2983942" y="945160"/>
            <a:ext cx="147637" cy="142875"/>
          </a:xfrm>
          <a:prstGeom prst="roundRect">
            <a:avLst/>
          </a:prstGeom>
          <a:noFill/>
          <a:ln w="9525">
            <a:solidFill>
              <a:srgbClr val="286CD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14" name="Rettangolo con angoli arrotondati 113">
            <a:extLst>
              <a:ext uri="{FF2B5EF4-FFF2-40B4-BE49-F238E27FC236}">
                <a16:creationId xmlns:a16="http://schemas.microsoft.com/office/drawing/2014/main" id="{AE62B763-C961-4A37-9810-9F61F21ACD51}"/>
              </a:ext>
            </a:extLst>
          </p:cNvPr>
          <p:cNvSpPr/>
          <p:nvPr/>
        </p:nvSpPr>
        <p:spPr>
          <a:xfrm>
            <a:off x="3012517" y="1771882"/>
            <a:ext cx="147637" cy="142875"/>
          </a:xfrm>
          <a:prstGeom prst="roundRect">
            <a:avLst/>
          </a:prstGeom>
          <a:noFill/>
          <a:ln w="9525">
            <a:solidFill>
              <a:srgbClr val="286CD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6EBC7C85-3D02-4FC8-9ED3-7E08F76F7BC4}"/>
              </a:ext>
            </a:extLst>
          </p:cNvPr>
          <p:cNvSpPr txBox="1"/>
          <p:nvPr/>
        </p:nvSpPr>
        <p:spPr>
          <a:xfrm>
            <a:off x="3492411" y="1216240"/>
            <a:ext cx="441146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>
              <a:defRPr sz="400">
                <a:solidFill>
                  <a:srgbClr val="E94D4D"/>
                </a:solidFill>
              </a:defRPr>
            </a:lvl1pPr>
          </a:lstStyle>
          <a:p>
            <a:r>
              <a:rPr lang="it-IT" dirty="0"/>
              <a:t>8835.1 c/</a:t>
            </a:r>
            <a:r>
              <a:rPr lang="it-IT" dirty="0" err="1"/>
              <a:t>mL</a:t>
            </a:r>
            <a:endParaRPr lang="it-IT" dirty="0"/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1195C00F-5825-488C-9F7B-A99C77E01856}"/>
              </a:ext>
            </a:extLst>
          </p:cNvPr>
          <p:cNvSpPr txBox="1"/>
          <p:nvPr/>
        </p:nvSpPr>
        <p:spPr>
          <a:xfrm>
            <a:off x="3492411" y="2062783"/>
            <a:ext cx="441146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>
              <a:defRPr sz="400">
                <a:solidFill>
                  <a:srgbClr val="E94D4D"/>
                </a:solidFill>
              </a:defRPr>
            </a:lvl1pPr>
          </a:lstStyle>
          <a:p>
            <a:r>
              <a:rPr lang="it-IT" dirty="0"/>
              <a:t>5826.5 c/</a:t>
            </a:r>
            <a:r>
              <a:rPr lang="it-IT" dirty="0" err="1"/>
              <a:t>mL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29712776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0</TotalTime>
  <Words>73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tteo Allegretti</dc:creator>
  <cp:lastModifiedBy>Matteo Allegretti</cp:lastModifiedBy>
  <cp:revision>44</cp:revision>
  <dcterms:created xsi:type="dcterms:W3CDTF">2020-01-05T11:53:04Z</dcterms:created>
  <dcterms:modified xsi:type="dcterms:W3CDTF">2021-01-28T09:07:10Z</dcterms:modified>
</cp:coreProperties>
</file>